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166" autoAdjust="0"/>
    <p:restoredTop sz="94660"/>
  </p:normalViewPr>
  <p:slideViewPr>
    <p:cSldViewPr snapToGrid="0">
      <p:cViewPr varScale="1">
        <p:scale>
          <a:sx n="80" d="100"/>
          <a:sy n="80" d="100"/>
        </p:scale>
        <p:origin x="3228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417FC-9BE7-4117-B137-3C681EE87BEA}" type="datetimeFigureOut">
              <a:rPr lang="de-DE" smtClean="0"/>
              <a:t>17.09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26095-163D-4C46-9069-59EA3B3D31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33164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417FC-9BE7-4117-B137-3C681EE87BEA}" type="datetimeFigureOut">
              <a:rPr lang="de-DE" smtClean="0"/>
              <a:t>17.09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26095-163D-4C46-9069-59EA3B3D31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853354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417FC-9BE7-4117-B137-3C681EE87BEA}" type="datetimeFigureOut">
              <a:rPr lang="de-DE" smtClean="0"/>
              <a:t>17.09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26095-163D-4C46-9069-59EA3B3D31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029609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417FC-9BE7-4117-B137-3C681EE87BEA}" type="datetimeFigureOut">
              <a:rPr lang="de-DE" smtClean="0"/>
              <a:t>17.09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26095-163D-4C46-9069-59EA3B3D31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470250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417FC-9BE7-4117-B137-3C681EE87BEA}" type="datetimeFigureOut">
              <a:rPr lang="de-DE" smtClean="0"/>
              <a:t>17.09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26095-163D-4C46-9069-59EA3B3D31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372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417FC-9BE7-4117-B137-3C681EE87BEA}" type="datetimeFigureOut">
              <a:rPr lang="de-DE" smtClean="0"/>
              <a:t>17.09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26095-163D-4C46-9069-59EA3B3D31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989145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417FC-9BE7-4117-B137-3C681EE87BEA}" type="datetimeFigureOut">
              <a:rPr lang="de-DE" smtClean="0"/>
              <a:t>17.09.2020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26095-163D-4C46-9069-59EA3B3D31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545654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417FC-9BE7-4117-B137-3C681EE87BEA}" type="datetimeFigureOut">
              <a:rPr lang="de-DE" smtClean="0"/>
              <a:t>17.09.2020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26095-163D-4C46-9069-59EA3B3D31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95216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417FC-9BE7-4117-B137-3C681EE87BEA}" type="datetimeFigureOut">
              <a:rPr lang="de-DE" smtClean="0"/>
              <a:t>17.09.2020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26095-163D-4C46-9069-59EA3B3D31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817472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417FC-9BE7-4117-B137-3C681EE87BEA}" type="datetimeFigureOut">
              <a:rPr lang="de-DE" smtClean="0"/>
              <a:t>17.09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26095-163D-4C46-9069-59EA3B3D31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778108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417FC-9BE7-4117-B137-3C681EE87BEA}" type="datetimeFigureOut">
              <a:rPr lang="de-DE" smtClean="0"/>
              <a:t>17.09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D26095-163D-4C46-9069-59EA3B3D31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622268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2417FC-9BE7-4117-B137-3C681EE87BEA}" type="datetimeFigureOut">
              <a:rPr lang="de-DE" smtClean="0"/>
              <a:t>17.09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D26095-163D-4C46-9069-59EA3B3D31D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646014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/>
          <a:srcRect l="20334" t="14623" r="7141" b="18006"/>
          <a:stretch/>
        </p:blipFill>
        <p:spPr>
          <a:xfrm>
            <a:off x="1106416" y="831113"/>
            <a:ext cx="1868405" cy="1839069"/>
          </a:xfrm>
          <a:prstGeom prst="rect">
            <a:avLst/>
          </a:prstGeom>
        </p:spPr>
      </p:pic>
      <p:sp>
        <p:nvSpPr>
          <p:cNvPr id="6" name="Textfeld 5"/>
          <p:cNvSpPr txBox="1"/>
          <p:nvPr/>
        </p:nvSpPr>
        <p:spPr>
          <a:xfrm>
            <a:off x="902762" y="2495234"/>
            <a:ext cx="235381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767031" y="2166729"/>
            <a:ext cx="371111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767031" y="1844203"/>
            <a:ext cx="371111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767031" y="1516736"/>
            <a:ext cx="371111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767031" y="1195436"/>
            <a:ext cx="371111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635831" y="875584"/>
            <a:ext cx="502312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923119" y="2618353"/>
            <a:ext cx="429807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de-DE" sz="9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1298695" y="2618353"/>
            <a:ext cx="429807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de-DE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1688781" y="2618353"/>
            <a:ext cx="429807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de-DE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2064357" y="2618353"/>
            <a:ext cx="429807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de-DE" sz="9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2439933" y="2618353"/>
            <a:ext cx="429807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de-DE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1085346" y="259541"/>
            <a:ext cx="17063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C3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de-DE" sz="9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900" dirty="0" err="1" smtClean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complexed</a:t>
            </a:r>
            <a:r>
              <a:rPr lang="de-DE" sz="900" dirty="0" smtClean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timiR</a:t>
            </a:r>
            <a:r>
              <a:rPr lang="de-DE" sz="900" dirty="0" smtClean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-FAM</a:t>
            </a:r>
          </a:p>
          <a:p>
            <a:r>
              <a:rPr lang="de-DE" sz="9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I/</a:t>
            </a:r>
            <a:r>
              <a:rPr lang="de-DE" sz="9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timiR</a:t>
            </a:r>
            <a:r>
              <a:rPr lang="de-DE" sz="9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FAM</a:t>
            </a:r>
            <a:endParaRPr lang="de-DE" sz="900" dirty="0" smtClean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1219467" y="2803880"/>
            <a:ext cx="1595002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luorescence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 rot="16200000">
            <a:off x="-58920" y="1644636"/>
            <a:ext cx="1661079" cy="246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rmalized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unts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/>
          <p:cNvSpPr txBox="1"/>
          <p:nvPr/>
        </p:nvSpPr>
        <p:spPr>
          <a:xfrm>
            <a:off x="4787338" y="2613738"/>
            <a:ext cx="429807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de-DE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5056813" y="2613738"/>
            <a:ext cx="429807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de-DE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23"/>
          <p:cNvSpPr txBox="1"/>
          <p:nvPr/>
        </p:nvSpPr>
        <p:spPr>
          <a:xfrm>
            <a:off x="5321743" y="2613738"/>
            <a:ext cx="429807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de-DE" sz="9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5592473" y="2613738"/>
            <a:ext cx="429807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de-DE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4270494" y="2803879"/>
            <a:ext cx="1595002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luorescence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4516375" y="2613738"/>
            <a:ext cx="429807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de-DE" sz="9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4250094" y="2613738"/>
            <a:ext cx="429807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de-DE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3978087" y="2613738"/>
            <a:ext cx="429807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de-DE" sz="9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3958205" y="2494397"/>
            <a:ext cx="235381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3958205" y="2279765"/>
            <a:ext cx="235381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2" name="Textfeld 31"/>
          <p:cNvSpPr txBox="1"/>
          <p:nvPr/>
        </p:nvSpPr>
        <p:spPr>
          <a:xfrm>
            <a:off x="3958205" y="2066169"/>
            <a:ext cx="235381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33" name="Textfeld 32"/>
          <p:cNvSpPr txBox="1"/>
          <p:nvPr/>
        </p:nvSpPr>
        <p:spPr>
          <a:xfrm>
            <a:off x="3958205" y="1852573"/>
            <a:ext cx="235381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3958205" y="1637666"/>
            <a:ext cx="235381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35" name="Textfeld 34"/>
          <p:cNvSpPr txBox="1"/>
          <p:nvPr/>
        </p:nvSpPr>
        <p:spPr>
          <a:xfrm>
            <a:off x="3958205" y="1425623"/>
            <a:ext cx="235381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3958205" y="1208483"/>
            <a:ext cx="235381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3958205" y="994886"/>
            <a:ext cx="235381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38" name="Textfeld 37"/>
          <p:cNvSpPr txBox="1"/>
          <p:nvPr/>
        </p:nvSpPr>
        <p:spPr>
          <a:xfrm>
            <a:off x="3958205" y="783007"/>
            <a:ext cx="235381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feld 38"/>
          <p:cNvSpPr txBox="1"/>
          <p:nvPr/>
        </p:nvSpPr>
        <p:spPr>
          <a:xfrm rot="16200000">
            <a:off x="2977622" y="1582816"/>
            <a:ext cx="1661079" cy="246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SSC-A (10</a:t>
            </a:r>
            <a:r>
              <a:rPr lang="de-DE" sz="9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4159168" y="343645"/>
            <a:ext cx="17063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complexed</a:t>
            </a:r>
            <a:r>
              <a:rPr lang="de-DE" sz="900" dirty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timiR</a:t>
            </a:r>
            <a:r>
              <a:rPr lang="de-DE" sz="900" dirty="0" smtClean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-FAM</a:t>
            </a:r>
            <a:endParaRPr lang="de-DE" sz="900" dirty="0">
              <a:solidFill>
                <a:schemeClr val="accent1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9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I/</a:t>
            </a:r>
            <a:r>
              <a:rPr lang="de-DE" sz="9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timiR</a:t>
            </a:r>
            <a:r>
              <a:rPr lang="de-DE" sz="9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FAM</a:t>
            </a:r>
            <a:endParaRPr lang="de-DE" sz="900" dirty="0" smtClean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2" name="Grafik 41"/>
          <p:cNvPicPr>
            <a:picLocks noChangeAspect="1"/>
          </p:cNvPicPr>
          <p:nvPr/>
        </p:nvPicPr>
        <p:blipFill rotWithShape="1">
          <a:blip r:embed="rId3"/>
          <a:srcRect l="17927" t="12108" r="7218" b="19040"/>
          <a:stretch/>
        </p:blipFill>
        <p:spPr>
          <a:xfrm>
            <a:off x="4159169" y="815340"/>
            <a:ext cx="1880684" cy="1854841"/>
          </a:xfrm>
          <a:prstGeom prst="rect">
            <a:avLst/>
          </a:prstGeom>
        </p:spPr>
      </p:pic>
      <p:pic>
        <p:nvPicPr>
          <p:cNvPr id="43" name="Grafik 42"/>
          <p:cNvPicPr>
            <a:picLocks noChangeAspect="1"/>
          </p:cNvPicPr>
          <p:nvPr/>
        </p:nvPicPr>
        <p:blipFill rotWithShape="1">
          <a:blip r:embed="rId4"/>
          <a:srcRect l="17154" t="8367" r="6992" b="18846"/>
          <a:stretch/>
        </p:blipFill>
        <p:spPr>
          <a:xfrm>
            <a:off x="4141103" y="3586491"/>
            <a:ext cx="1898750" cy="1848056"/>
          </a:xfrm>
          <a:prstGeom prst="rect">
            <a:avLst/>
          </a:prstGeom>
        </p:spPr>
      </p:pic>
      <p:sp>
        <p:nvSpPr>
          <p:cNvPr id="44" name="Textfeld 43"/>
          <p:cNvSpPr txBox="1"/>
          <p:nvPr/>
        </p:nvSpPr>
        <p:spPr>
          <a:xfrm>
            <a:off x="3957073" y="5258280"/>
            <a:ext cx="235381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feld 44"/>
          <p:cNvSpPr txBox="1"/>
          <p:nvPr/>
        </p:nvSpPr>
        <p:spPr>
          <a:xfrm>
            <a:off x="3957073" y="5040856"/>
            <a:ext cx="235381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46" name="Textfeld 45"/>
          <p:cNvSpPr txBox="1"/>
          <p:nvPr/>
        </p:nvSpPr>
        <p:spPr>
          <a:xfrm>
            <a:off x="3957073" y="4832845"/>
            <a:ext cx="235381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47" name="Textfeld 46"/>
          <p:cNvSpPr txBox="1"/>
          <p:nvPr/>
        </p:nvSpPr>
        <p:spPr>
          <a:xfrm>
            <a:off x="3957073" y="4619249"/>
            <a:ext cx="235381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feld 47"/>
          <p:cNvSpPr txBox="1"/>
          <p:nvPr/>
        </p:nvSpPr>
        <p:spPr>
          <a:xfrm>
            <a:off x="3957073" y="4409927"/>
            <a:ext cx="235381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49" name="Textfeld 48"/>
          <p:cNvSpPr txBox="1"/>
          <p:nvPr/>
        </p:nvSpPr>
        <p:spPr>
          <a:xfrm>
            <a:off x="3957073" y="4197884"/>
            <a:ext cx="235381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feld 49"/>
          <p:cNvSpPr txBox="1"/>
          <p:nvPr/>
        </p:nvSpPr>
        <p:spPr>
          <a:xfrm>
            <a:off x="3957073" y="3991099"/>
            <a:ext cx="235381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feld 50"/>
          <p:cNvSpPr txBox="1"/>
          <p:nvPr/>
        </p:nvSpPr>
        <p:spPr>
          <a:xfrm>
            <a:off x="3957073" y="3775524"/>
            <a:ext cx="235381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52" name="Textfeld 51"/>
          <p:cNvSpPr txBox="1"/>
          <p:nvPr/>
        </p:nvSpPr>
        <p:spPr>
          <a:xfrm>
            <a:off x="3957073" y="3569229"/>
            <a:ext cx="235381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feld 52"/>
          <p:cNvSpPr txBox="1"/>
          <p:nvPr/>
        </p:nvSpPr>
        <p:spPr>
          <a:xfrm rot="16200000">
            <a:off x="3051214" y="4402223"/>
            <a:ext cx="1661079" cy="246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SSC-A (10</a:t>
            </a:r>
            <a:r>
              <a:rPr lang="de-DE" sz="9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feld 53"/>
          <p:cNvSpPr txBox="1"/>
          <p:nvPr/>
        </p:nvSpPr>
        <p:spPr>
          <a:xfrm>
            <a:off x="4780748" y="5380250"/>
            <a:ext cx="429807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de-DE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feld 54"/>
          <p:cNvSpPr txBox="1"/>
          <p:nvPr/>
        </p:nvSpPr>
        <p:spPr>
          <a:xfrm>
            <a:off x="5050222" y="5380250"/>
            <a:ext cx="429807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de-DE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feld 55"/>
          <p:cNvSpPr txBox="1"/>
          <p:nvPr/>
        </p:nvSpPr>
        <p:spPr>
          <a:xfrm>
            <a:off x="5315153" y="5380250"/>
            <a:ext cx="429807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de-DE" sz="9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feld 56"/>
          <p:cNvSpPr txBox="1"/>
          <p:nvPr/>
        </p:nvSpPr>
        <p:spPr>
          <a:xfrm>
            <a:off x="5585883" y="5380250"/>
            <a:ext cx="429807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de-DE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feld 57"/>
          <p:cNvSpPr txBox="1"/>
          <p:nvPr/>
        </p:nvSpPr>
        <p:spPr>
          <a:xfrm>
            <a:off x="4270950" y="5563052"/>
            <a:ext cx="1595002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luorescence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feld 58"/>
          <p:cNvSpPr txBox="1"/>
          <p:nvPr/>
        </p:nvSpPr>
        <p:spPr>
          <a:xfrm>
            <a:off x="4509785" y="5380250"/>
            <a:ext cx="429807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de-DE" sz="9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feld 59"/>
          <p:cNvSpPr txBox="1"/>
          <p:nvPr/>
        </p:nvSpPr>
        <p:spPr>
          <a:xfrm>
            <a:off x="4243504" y="5380250"/>
            <a:ext cx="429807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de-DE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feld 60"/>
          <p:cNvSpPr txBox="1"/>
          <p:nvPr/>
        </p:nvSpPr>
        <p:spPr>
          <a:xfrm>
            <a:off x="3971497" y="5380250"/>
            <a:ext cx="429807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de-DE" sz="9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feld 61"/>
          <p:cNvSpPr txBox="1"/>
          <p:nvPr/>
        </p:nvSpPr>
        <p:spPr>
          <a:xfrm>
            <a:off x="4185108" y="3411847"/>
            <a:ext cx="17063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complexed</a:t>
            </a:r>
            <a:r>
              <a:rPr lang="de-DE" sz="900" dirty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timiR</a:t>
            </a:r>
            <a:r>
              <a:rPr lang="de-DE" sz="900" dirty="0" smtClean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-FAM</a:t>
            </a:r>
            <a:endParaRPr lang="de-DE" sz="900" dirty="0">
              <a:solidFill>
                <a:schemeClr val="accent1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3" name="Grafik 62"/>
          <p:cNvPicPr>
            <a:picLocks noChangeAspect="1"/>
          </p:cNvPicPr>
          <p:nvPr/>
        </p:nvPicPr>
        <p:blipFill rotWithShape="1">
          <a:blip r:embed="rId5"/>
          <a:srcRect l="18040" t="8995" r="7454" b="19770"/>
          <a:stretch/>
        </p:blipFill>
        <p:spPr>
          <a:xfrm>
            <a:off x="1201656" y="3614475"/>
            <a:ext cx="1863111" cy="1787100"/>
          </a:xfrm>
          <a:prstGeom prst="rect">
            <a:avLst/>
          </a:prstGeom>
        </p:spPr>
      </p:pic>
      <p:sp>
        <p:nvSpPr>
          <p:cNvPr id="64" name="Textfeld 63"/>
          <p:cNvSpPr txBox="1"/>
          <p:nvPr/>
        </p:nvSpPr>
        <p:spPr>
          <a:xfrm>
            <a:off x="1028173" y="5248934"/>
            <a:ext cx="201314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feld 64"/>
          <p:cNvSpPr txBox="1"/>
          <p:nvPr/>
        </p:nvSpPr>
        <p:spPr>
          <a:xfrm>
            <a:off x="1028173" y="5035921"/>
            <a:ext cx="201314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66" name="Textfeld 65"/>
          <p:cNvSpPr txBox="1"/>
          <p:nvPr/>
        </p:nvSpPr>
        <p:spPr>
          <a:xfrm>
            <a:off x="1028173" y="4827909"/>
            <a:ext cx="201314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67" name="Textfeld 66"/>
          <p:cNvSpPr txBox="1"/>
          <p:nvPr/>
        </p:nvSpPr>
        <p:spPr>
          <a:xfrm>
            <a:off x="1028173" y="4618724"/>
            <a:ext cx="201314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feld 67"/>
          <p:cNvSpPr txBox="1"/>
          <p:nvPr/>
        </p:nvSpPr>
        <p:spPr>
          <a:xfrm>
            <a:off x="1028173" y="4413814"/>
            <a:ext cx="201314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69" name="Textfeld 68"/>
          <p:cNvSpPr txBox="1"/>
          <p:nvPr/>
        </p:nvSpPr>
        <p:spPr>
          <a:xfrm>
            <a:off x="1028173" y="4206182"/>
            <a:ext cx="201314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feld 69"/>
          <p:cNvSpPr txBox="1"/>
          <p:nvPr/>
        </p:nvSpPr>
        <p:spPr>
          <a:xfrm>
            <a:off x="1028173" y="3999397"/>
            <a:ext cx="201314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feld 70"/>
          <p:cNvSpPr txBox="1"/>
          <p:nvPr/>
        </p:nvSpPr>
        <p:spPr>
          <a:xfrm>
            <a:off x="1028173" y="3788233"/>
            <a:ext cx="201314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72" name="Textfeld 71"/>
          <p:cNvSpPr txBox="1"/>
          <p:nvPr/>
        </p:nvSpPr>
        <p:spPr>
          <a:xfrm>
            <a:off x="1028173" y="3581938"/>
            <a:ext cx="201314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feld 72"/>
          <p:cNvSpPr txBox="1"/>
          <p:nvPr/>
        </p:nvSpPr>
        <p:spPr>
          <a:xfrm rot="16200000">
            <a:off x="63191" y="4431331"/>
            <a:ext cx="1729164" cy="246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SSC-A (10</a:t>
            </a:r>
            <a:r>
              <a:rPr lang="de-DE" sz="9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feld 73"/>
          <p:cNvSpPr txBox="1"/>
          <p:nvPr/>
        </p:nvSpPr>
        <p:spPr>
          <a:xfrm>
            <a:off x="1816433" y="5376048"/>
            <a:ext cx="429807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de-DE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feld 74"/>
          <p:cNvSpPr txBox="1"/>
          <p:nvPr/>
        </p:nvSpPr>
        <p:spPr>
          <a:xfrm>
            <a:off x="2085907" y="5376048"/>
            <a:ext cx="429807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de-DE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feld 75"/>
          <p:cNvSpPr txBox="1"/>
          <p:nvPr/>
        </p:nvSpPr>
        <p:spPr>
          <a:xfrm>
            <a:off x="2350837" y="5376048"/>
            <a:ext cx="429807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de-DE" sz="9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feld 76"/>
          <p:cNvSpPr txBox="1"/>
          <p:nvPr/>
        </p:nvSpPr>
        <p:spPr>
          <a:xfrm>
            <a:off x="2621567" y="5376048"/>
            <a:ext cx="429807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de-DE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feld 77"/>
          <p:cNvSpPr txBox="1"/>
          <p:nvPr/>
        </p:nvSpPr>
        <p:spPr>
          <a:xfrm>
            <a:off x="1306634" y="5558851"/>
            <a:ext cx="1595002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luorescence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feld 78"/>
          <p:cNvSpPr txBox="1"/>
          <p:nvPr/>
        </p:nvSpPr>
        <p:spPr>
          <a:xfrm>
            <a:off x="1545469" y="5376048"/>
            <a:ext cx="429807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de-DE" sz="9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feld 79"/>
          <p:cNvSpPr txBox="1"/>
          <p:nvPr/>
        </p:nvSpPr>
        <p:spPr>
          <a:xfrm>
            <a:off x="1279188" y="5376048"/>
            <a:ext cx="429807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de-DE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feld 80"/>
          <p:cNvSpPr txBox="1"/>
          <p:nvPr/>
        </p:nvSpPr>
        <p:spPr>
          <a:xfrm>
            <a:off x="1007181" y="5376048"/>
            <a:ext cx="429807" cy="251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de-DE" sz="9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feld 81"/>
          <p:cNvSpPr txBox="1"/>
          <p:nvPr/>
        </p:nvSpPr>
        <p:spPr>
          <a:xfrm>
            <a:off x="1188131" y="3441259"/>
            <a:ext cx="15694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PC3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feld 1"/>
          <p:cNvSpPr txBox="1"/>
          <p:nvPr/>
        </p:nvSpPr>
        <p:spPr>
          <a:xfrm>
            <a:off x="5032276" y="9629001"/>
            <a:ext cx="18224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Kunz et al., </a:t>
            </a:r>
            <a:r>
              <a:rPr lang="de-DE" sz="1200" dirty="0" err="1" smtClean="0"/>
              <a:t>Suppl</a:t>
            </a:r>
            <a:r>
              <a:rPr lang="de-DE" sz="1200" dirty="0" smtClean="0"/>
              <a:t>. </a:t>
            </a:r>
            <a:r>
              <a:rPr lang="de-DE" sz="1200" dirty="0" err="1" smtClean="0"/>
              <a:t>Figure</a:t>
            </a:r>
            <a:r>
              <a:rPr lang="de-DE" sz="1200" dirty="0" smtClean="0"/>
              <a:t> 1</a:t>
            </a:r>
            <a:endParaRPr lang="de-DE" sz="1200" dirty="0"/>
          </a:p>
        </p:txBody>
      </p:sp>
      <p:sp>
        <p:nvSpPr>
          <p:cNvPr id="83" name="Textfeld 82"/>
          <p:cNvSpPr txBox="1"/>
          <p:nvPr/>
        </p:nvSpPr>
        <p:spPr>
          <a:xfrm>
            <a:off x="142875" y="-3995"/>
            <a:ext cx="2670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a</a:t>
            </a:r>
            <a:endParaRPr lang="de-DE" dirty="0"/>
          </a:p>
        </p:txBody>
      </p:sp>
      <p:sp>
        <p:nvSpPr>
          <p:cNvPr id="84" name="Textfeld 83"/>
          <p:cNvSpPr txBox="1"/>
          <p:nvPr/>
        </p:nvSpPr>
        <p:spPr>
          <a:xfrm>
            <a:off x="142875" y="6079305"/>
            <a:ext cx="2670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b</a:t>
            </a:r>
            <a:endParaRPr lang="de-DE" dirty="0"/>
          </a:p>
        </p:txBody>
      </p:sp>
      <p:sp>
        <p:nvSpPr>
          <p:cNvPr id="95" name="Textfeld 94"/>
          <p:cNvSpPr txBox="1"/>
          <p:nvPr/>
        </p:nvSpPr>
        <p:spPr>
          <a:xfrm rot="18430697">
            <a:off x="999877" y="8516150"/>
            <a:ext cx="1006050" cy="4535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EI/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eg.ctrl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timiR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Grafik 19"/>
          <p:cNvPicPr>
            <a:picLocks noChangeAspect="1"/>
          </p:cNvPicPr>
          <p:nvPr/>
        </p:nvPicPr>
        <p:blipFill rotWithShape="1">
          <a:blip r:embed="rId6"/>
          <a:srcRect l="5240" t="6295" r="6981" b="4662"/>
          <a:stretch/>
        </p:blipFill>
        <p:spPr>
          <a:xfrm>
            <a:off x="1242278" y="6434459"/>
            <a:ext cx="1798109" cy="2002704"/>
          </a:xfrm>
          <a:prstGeom prst="rect">
            <a:avLst/>
          </a:prstGeom>
        </p:spPr>
      </p:pic>
      <p:pic>
        <p:nvPicPr>
          <p:cNvPr id="41" name="Grafik 40"/>
          <p:cNvPicPr>
            <a:picLocks noChangeAspect="1"/>
          </p:cNvPicPr>
          <p:nvPr/>
        </p:nvPicPr>
        <p:blipFill rotWithShape="1">
          <a:blip r:embed="rId7"/>
          <a:srcRect l="5344" t="5423" r="6975" b="4535"/>
          <a:stretch/>
        </p:blipFill>
        <p:spPr>
          <a:xfrm>
            <a:off x="4224170" y="6414411"/>
            <a:ext cx="1798110" cy="2025144"/>
          </a:xfrm>
          <a:prstGeom prst="rect">
            <a:avLst/>
          </a:prstGeom>
        </p:spPr>
      </p:pic>
      <p:sp>
        <p:nvSpPr>
          <p:cNvPr id="97" name="Textfeld 96"/>
          <p:cNvSpPr txBox="1"/>
          <p:nvPr/>
        </p:nvSpPr>
        <p:spPr>
          <a:xfrm rot="18430697">
            <a:off x="1368841" y="8674548"/>
            <a:ext cx="1147933" cy="2834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EI/antimiR-375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feld 97"/>
          <p:cNvSpPr txBox="1"/>
          <p:nvPr/>
        </p:nvSpPr>
        <p:spPr>
          <a:xfrm rot="18430697">
            <a:off x="1860637" y="8674548"/>
            <a:ext cx="1147933" cy="2834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EI/antimiR-141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feld 98"/>
          <p:cNvSpPr txBox="1"/>
          <p:nvPr/>
        </p:nvSpPr>
        <p:spPr>
          <a:xfrm rot="18430697">
            <a:off x="3687725" y="8760751"/>
            <a:ext cx="1273381" cy="2834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eg.ctrl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timiR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feld 99"/>
          <p:cNvSpPr txBox="1"/>
          <p:nvPr/>
        </p:nvSpPr>
        <p:spPr>
          <a:xfrm rot="18430697">
            <a:off x="4422028" y="8654252"/>
            <a:ext cx="1006050" cy="2834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antimiR-375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feld 100"/>
          <p:cNvSpPr txBox="1"/>
          <p:nvPr/>
        </p:nvSpPr>
        <p:spPr>
          <a:xfrm rot="18430697">
            <a:off x="4900046" y="8654252"/>
            <a:ext cx="1006050" cy="2834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antimiR-141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feld 109"/>
          <p:cNvSpPr txBox="1"/>
          <p:nvPr/>
        </p:nvSpPr>
        <p:spPr>
          <a:xfrm rot="16200000">
            <a:off x="2908722" y="7270925"/>
            <a:ext cx="1985153" cy="2834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iable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(%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neg.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. +/- SD)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feld 110"/>
          <p:cNvSpPr txBox="1"/>
          <p:nvPr/>
        </p:nvSpPr>
        <p:spPr>
          <a:xfrm>
            <a:off x="1031453" y="8279592"/>
            <a:ext cx="2973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feld 111"/>
          <p:cNvSpPr txBox="1"/>
          <p:nvPr/>
        </p:nvSpPr>
        <p:spPr>
          <a:xfrm>
            <a:off x="897774" y="8012995"/>
            <a:ext cx="4310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feld 112"/>
          <p:cNvSpPr txBox="1"/>
          <p:nvPr/>
        </p:nvSpPr>
        <p:spPr>
          <a:xfrm>
            <a:off x="897774" y="7749303"/>
            <a:ext cx="4310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feld 113"/>
          <p:cNvSpPr txBox="1"/>
          <p:nvPr/>
        </p:nvSpPr>
        <p:spPr>
          <a:xfrm>
            <a:off x="897774" y="7488414"/>
            <a:ext cx="4310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feld 114"/>
          <p:cNvSpPr txBox="1"/>
          <p:nvPr/>
        </p:nvSpPr>
        <p:spPr>
          <a:xfrm>
            <a:off x="897774" y="7233264"/>
            <a:ext cx="4310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feld 115"/>
          <p:cNvSpPr txBox="1"/>
          <p:nvPr/>
        </p:nvSpPr>
        <p:spPr>
          <a:xfrm>
            <a:off x="897774" y="6971416"/>
            <a:ext cx="4310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feld 116"/>
          <p:cNvSpPr txBox="1"/>
          <p:nvPr/>
        </p:nvSpPr>
        <p:spPr>
          <a:xfrm>
            <a:off x="897774" y="6713975"/>
            <a:ext cx="4310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2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feld 117"/>
          <p:cNvSpPr txBox="1"/>
          <p:nvPr/>
        </p:nvSpPr>
        <p:spPr>
          <a:xfrm>
            <a:off x="897774" y="6451107"/>
            <a:ext cx="4310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feld 118"/>
          <p:cNvSpPr txBox="1"/>
          <p:nvPr/>
        </p:nvSpPr>
        <p:spPr>
          <a:xfrm rot="16200000">
            <a:off x="-67617" y="7270925"/>
            <a:ext cx="1985153" cy="2834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iable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(%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neg.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. +/- SD)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feld 119"/>
          <p:cNvSpPr txBox="1"/>
          <p:nvPr/>
        </p:nvSpPr>
        <p:spPr>
          <a:xfrm>
            <a:off x="4001941" y="8281875"/>
            <a:ext cx="2973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feld 120"/>
          <p:cNvSpPr txBox="1"/>
          <p:nvPr/>
        </p:nvSpPr>
        <p:spPr>
          <a:xfrm>
            <a:off x="3868262" y="8015278"/>
            <a:ext cx="4310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feld 121"/>
          <p:cNvSpPr txBox="1"/>
          <p:nvPr/>
        </p:nvSpPr>
        <p:spPr>
          <a:xfrm>
            <a:off x="3868262" y="7751586"/>
            <a:ext cx="4310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feld 122"/>
          <p:cNvSpPr txBox="1"/>
          <p:nvPr/>
        </p:nvSpPr>
        <p:spPr>
          <a:xfrm>
            <a:off x="3868262" y="7490697"/>
            <a:ext cx="4310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feld 123"/>
          <p:cNvSpPr txBox="1"/>
          <p:nvPr/>
        </p:nvSpPr>
        <p:spPr>
          <a:xfrm>
            <a:off x="3868262" y="7235547"/>
            <a:ext cx="4310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feld 124"/>
          <p:cNvSpPr txBox="1"/>
          <p:nvPr/>
        </p:nvSpPr>
        <p:spPr>
          <a:xfrm>
            <a:off x="3868262" y="6973699"/>
            <a:ext cx="4310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feld 125"/>
          <p:cNvSpPr txBox="1"/>
          <p:nvPr/>
        </p:nvSpPr>
        <p:spPr>
          <a:xfrm>
            <a:off x="3868262" y="6716258"/>
            <a:ext cx="4310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2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feld 126"/>
          <p:cNvSpPr txBox="1"/>
          <p:nvPr/>
        </p:nvSpPr>
        <p:spPr>
          <a:xfrm>
            <a:off x="3868262" y="6453390"/>
            <a:ext cx="4310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feld 2"/>
          <p:cNvSpPr txBox="1"/>
          <p:nvPr/>
        </p:nvSpPr>
        <p:spPr>
          <a:xfrm>
            <a:off x="1985842" y="7457636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**</a:t>
            </a:r>
            <a:endParaRPr lang="de-DE" sz="1200" dirty="0"/>
          </a:p>
        </p:txBody>
      </p:sp>
      <p:sp>
        <p:nvSpPr>
          <p:cNvPr id="107" name="Textfeld 106"/>
          <p:cNvSpPr txBox="1"/>
          <p:nvPr/>
        </p:nvSpPr>
        <p:spPr>
          <a:xfrm>
            <a:off x="2480148" y="7458960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**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24185073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55</Words>
  <Application>Microsoft Office PowerPoint</Application>
  <PresentationFormat>A4-Papier (210 x 297 mm)</PresentationFormat>
  <Paragraphs>103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Universitätsklinikum Leipzig Aö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Ewe, Alexander</dc:creator>
  <cp:lastModifiedBy>Aigner, Achim</cp:lastModifiedBy>
  <cp:revision>18</cp:revision>
  <dcterms:created xsi:type="dcterms:W3CDTF">2020-09-07T15:26:51Z</dcterms:created>
  <dcterms:modified xsi:type="dcterms:W3CDTF">2020-09-17T10:18:36Z</dcterms:modified>
</cp:coreProperties>
</file>